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handoutMasterIdLst>
    <p:handoutMasterId r:id="rId4"/>
  </p:handoutMasterIdLst>
  <p:sldIdLst>
    <p:sldId id="261" r:id="rId2"/>
  </p:sldIdLst>
  <p:sldSz cx="12960350" cy="21959888"/>
  <p:notesSz cx="6889750" cy="100218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068" autoAdjust="0"/>
    <p:restoredTop sz="94660"/>
  </p:normalViewPr>
  <p:slideViewPr>
    <p:cSldViewPr snapToGrid="0">
      <p:cViewPr>
        <p:scale>
          <a:sx n="48" d="100"/>
          <a:sy n="48" d="100"/>
        </p:scale>
        <p:origin x="-1542" y="528"/>
      </p:cViewPr>
      <p:guideLst>
        <p:guide orient="horz" pos="6916"/>
        <p:guide pos="408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5558" cy="502835"/>
          </a:xfrm>
          <a:prstGeom prst="rect">
            <a:avLst/>
          </a:prstGeom>
        </p:spPr>
        <p:txBody>
          <a:bodyPr vert="horz" lIns="96634" tIns="48317" rIns="96634" bIns="48317" rtlCol="0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3902597" y="0"/>
            <a:ext cx="2985558" cy="502835"/>
          </a:xfrm>
          <a:prstGeom prst="rect">
            <a:avLst/>
          </a:prstGeom>
        </p:spPr>
        <p:txBody>
          <a:bodyPr vert="horz" lIns="96634" tIns="48317" rIns="96634" bIns="48317" rtlCol="0"/>
          <a:lstStyle>
            <a:lvl1pPr algn="r">
              <a:defRPr sz="1300"/>
            </a:lvl1pPr>
          </a:lstStyle>
          <a:p>
            <a:fld id="{0865300D-C0DB-4A38-BD44-A77EA31991B3}" type="datetimeFigureOut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0" y="9519055"/>
            <a:ext cx="2985558" cy="502834"/>
          </a:xfrm>
          <a:prstGeom prst="rect">
            <a:avLst/>
          </a:prstGeom>
        </p:spPr>
        <p:txBody>
          <a:bodyPr vert="horz" lIns="96634" tIns="48317" rIns="96634" bIns="48317" rtlCol="0" anchor="b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3902597" y="9519055"/>
            <a:ext cx="2985558" cy="502834"/>
          </a:xfrm>
          <a:prstGeom prst="rect">
            <a:avLst/>
          </a:prstGeom>
        </p:spPr>
        <p:txBody>
          <a:bodyPr vert="horz" lIns="96634" tIns="48317" rIns="96634" bIns="48317" rtlCol="0" anchor="b"/>
          <a:lstStyle>
            <a:lvl1pPr algn="r">
              <a:defRPr sz="1300"/>
            </a:lvl1pPr>
          </a:lstStyle>
          <a:p>
            <a:fld id="{674C055D-3DDC-4A69-8032-9333AC9DD4D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859915682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5558" cy="502835"/>
          </a:xfrm>
          <a:prstGeom prst="rect">
            <a:avLst/>
          </a:prstGeom>
        </p:spPr>
        <p:txBody>
          <a:bodyPr vert="horz" lIns="96634" tIns="48317" rIns="96634" bIns="48317" rtlCol="0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902597" y="0"/>
            <a:ext cx="2985558" cy="502835"/>
          </a:xfrm>
          <a:prstGeom prst="rect">
            <a:avLst/>
          </a:prstGeom>
        </p:spPr>
        <p:txBody>
          <a:bodyPr vert="horz" lIns="96634" tIns="48317" rIns="96634" bIns="48317" rtlCol="0"/>
          <a:lstStyle>
            <a:lvl1pPr algn="r">
              <a:defRPr sz="1300"/>
            </a:lvl1pPr>
          </a:lstStyle>
          <a:p>
            <a:fld id="{8CBEB62A-5263-4422-9935-2F8A43E720BE}" type="datetimeFigureOut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447925" y="1252538"/>
            <a:ext cx="1993900" cy="33829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34" tIns="48317" rIns="96634" bIns="48317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8975" y="4823034"/>
            <a:ext cx="5511800" cy="3946118"/>
          </a:xfrm>
          <a:prstGeom prst="rect">
            <a:avLst/>
          </a:prstGeom>
        </p:spPr>
        <p:txBody>
          <a:bodyPr vert="horz" lIns="96634" tIns="48317" rIns="96634" bIns="48317" rtlCol="0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519055"/>
            <a:ext cx="2985558" cy="502834"/>
          </a:xfrm>
          <a:prstGeom prst="rect">
            <a:avLst/>
          </a:prstGeom>
        </p:spPr>
        <p:txBody>
          <a:bodyPr vert="horz" lIns="96634" tIns="48317" rIns="96634" bIns="48317" rtlCol="0" anchor="b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902597" y="9519055"/>
            <a:ext cx="2985558" cy="502834"/>
          </a:xfrm>
          <a:prstGeom prst="rect">
            <a:avLst/>
          </a:prstGeom>
        </p:spPr>
        <p:txBody>
          <a:bodyPr vert="horz" lIns="96634" tIns="48317" rIns="96634" bIns="48317" rtlCol="0" anchor="b"/>
          <a:lstStyle>
            <a:lvl1pPr algn="r">
              <a:defRPr sz="1300"/>
            </a:lvl1pPr>
          </a:lstStyle>
          <a:p>
            <a:fld id="{D3554FBB-5347-4C5F-BB9D-09F70482850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920570996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  <p:notesStyle>
    <a:lvl1pPr marL="0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1pPr>
    <a:lvl2pPr marL="837965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2pPr>
    <a:lvl3pPr marL="1675930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3pPr>
    <a:lvl4pPr marL="2513895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4pPr>
    <a:lvl5pPr marL="3351860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5pPr>
    <a:lvl6pPr marL="4189826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6pPr>
    <a:lvl7pPr marL="5027791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7pPr>
    <a:lvl8pPr marL="5865756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8pPr>
    <a:lvl9pPr marL="6703721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72026" y="3593900"/>
            <a:ext cx="11016298" cy="7645294"/>
          </a:xfrm>
        </p:spPr>
        <p:txBody>
          <a:bodyPr anchor="b"/>
          <a:lstStyle>
            <a:lvl1pPr algn="ctr">
              <a:defRPr sz="8504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20045" y="11534026"/>
            <a:ext cx="9720263" cy="5301888"/>
          </a:xfrm>
        </p:spPr>
        <p:txBody>
          <a:bodyPr/>
          <a:lstStyle>
            <a:lvl1pPr marL="0" indent="0" algn="ctr">
              <a:buNone/>
              <a:defRPr sz="3402"/>
            </a:lvl1pPr>
            <a:lvl2pPr marL="648004" indent="0" algn="ctr">
              <a:buNone/>
              <a:defRPr sz="2835"/>
            </a:lvl2pPr>
            <a:lvl3pPr marL="1296008" indent="0" algn="ctr">
              <a:buNone/>
              <a:defRPr sz="2551"/>
            </a:lvl3pPr>
            <a:lvl4pPr marL="1944013" indent="0" algn="ctr">
              <a:buNone/>
              <a:defRPr sz="2268"/>
            </a:lvl4pPr>
            <a:lvl5pPr marL="2592017" indent="0" algn="ctr">
              <a:buNone/>
              <a:defRPr sz="2268"/>
            </a:lvl5pPr>
            <a:lvl6pPr marL="3240020" indent="0" algn="ctr">
              <a:buNone/>
              <a:defRPr sz="2268"/>
            </a:lvl6pPr>
            <a:lvl7pPr marL="3888025" indent="0" algn="ctr">
              <a:buNone/>
              <a:defRPr sz="2268"/>
            </a:lvl7pPr>
            <a:lvl8pPr marL="4536030" indent="0" algn="ctr">
              <a:buNone/>
              <a:defRPr sz="2268"/>
            </a:lvl8pPr>
            <a:lvl9pPr marL="5184033" indent="0" algn="ctr">
              <a:buNone/>
              <a:defRPr sz="2268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33E5F-05D8-4883-BBA5-F544EA65A67D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09468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78F2E-E25A-4875-A211-19CDE50E7B66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8634589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274753" y="1169161"/>
            <a:ext cx="2794575" cy="18609990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91025" y="1169161"/>
            <a:ext cx="8221722" cy="18609990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23612-7092-43E6-87EE-5F3D47EAF4DF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7751473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0705D-CDE0-4A8B-BD00-0C51EB3C5965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7144320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4275" y="5474729"/>
            <a:ext cx="11178302" cy="9134702"/>
          </a:xfrm>
        </p:spPr>
        <p:txBody>
          <a:bodyPr anchor="b"/>
          <a:lstStyle>
            <a:lvl1pPr>
              <a:defRPr sz="8504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4275" y="14695848"/>
            <a:ext cx="11178302" cy="4803724"/>
          </a:xfrm>
        </p:spPr>
        <p:txBody>
          <a:bodyPr/>
          <a:lstStyle>
            <a:lvl1pPr marL="0" indent="0">
              <a:buNone/>
              <a:defRPr sz="3402">
                <a:solidFill>
                  <a:schemeClr val="tx1"/>
                </a:solidFill>
              </a:defRPr>
            </a:lvl1pPr>
            <a:lvl2pPr marL="648004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2pPr>
            <a:lvl3pPr marL="1296008" indent="0">
              <a:buNone/>
              <a:defRPr sz="2551">
                <a:solidFill>
                  <a:schemeClr val="tx1">
                    <a:tint val="75000"/>
                  </a:schemeClr>
                </a:solidFill>
              </a:defRPr>
            </a:lvl3pPr>
            <a:lvl4pPr marL="1944013" indent="0">
              <a:buNone/>
              <a:defRPr sz="2268">
                <a:solidFill>
                  <a:schemeClr val="tx1">
                    <a:tint val="75000"/>
                  </a:schemeClr>
                </a:solidFill>
              </a:defRPr>
            </a:lvl4pPr>
            <a:lvl5pPr marL="2592017" indent="0">
              <a:buNone/>
              <a:defRPr sz="2268">
                <a:solidFill>
                  <a:schemeClr val="tx1">
                    <a:tint val="75000"/>
                  </a:schemeClr>
                </a:solidFill>
              </a:defRPr>
            </a:lvl5pPr>
            <a:lvl6pPr marL="3240020" indent="0">
              <a:buNone/>
              <a:defRPr sz="2268">
                <a:solidFill>
                  <a:schemeClr val="tx1">
                    <a:tint val="75000"/>
                  </a:schemeClr>
                </a:solidFill>
              </a:defRPr>
            </a:lvl6pPr>
            <a:lvl7pPr marL="3888025" indent="0">
              <a:buNone/>
              <a:defRPr sz="2268">
                <a:solidFill>
                  <a:schemeClr val="tx1">
                    <a:tint val="75000"/>
                  </a:schemeClr>
                </a:solidFill>
              </a:defRPr>
            </a:lvl7pPr>
            <a:lvl8pPr marL="4536030" indent="0">
              <a:buNone/>
              <a:defRPr sz="2268">
                <a:solidFill>
                  <a:schemeClr val="tx1">
                    <a:tint val="75000"/>
                  </a:schemeClr>
                </a:solidFill>
              </a:defRPr>
            </a:lvl8pPr>
            <a:lvl9pPr marL="5184033" indent="0">
              <a:buNone/>
              <a:defRPr sz="226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4F3DD-5303-44B3-94EB-3881814DB7A2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41112720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91024" y="5845805"/>
            <a:ext cx="5508149" cy="13933347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561179" y="5845805"/>
            <a:ext cx="5508149" cy="13933347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F68C83-F889-49C6-8258-A889429BD78F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4724813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92712" y="1169166"/>
            <a:ext cx="11178302" cy="4244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92715" y="5383224"/>
            <a:ext cx="5482835" cy="2638235"/>
          </a:xfrm>
        </p:spPr>
        <p:txBody>
          <a:bodyPr anchor="b"/>
          <a:lstStyle>
            <a:lvl1pPr marL="0" indent="0">
              <a:buNone/>
              <a:defRPr sz="3402" b="1"/>
            </a:lvl1pPr>
            <a:lvl2pPr marL="648004" indent="0">
              <a:buNone/>
              <a:defRPr sz="2835" b="1"/>
            </a:lvl2pPr>
            <a:lvl3pPr marL="1296008" indent="0">
              <a:buNone/>
              <a:defRPr sz="2551" b="1"/>
            </a:lvl3pPr>
            <a:lvl4pPr marL="1944013" indent="0">
              <a:buNone/>
              <a:defRPr sz="2268" b="1"/>
            </a:lvl4pPr>
            <a:lvl5pPr marL="2592017" indent="0">
              <a:buNone/>
              <a:defRPr sz="2268" b="1"/>
            </a:lvl5pPr>
            <a:lvl6pPr marL="3240020" indent="0">
              <a:buNone/>
              <a:defRPr sz="2268" b="1"/>
            </a:lvl6pPr>
            <a:lvl7pPr marL="3888025" indent="0">
              <a:buNone/>
              <a:defRPr sz="2268" b="1"/>
            </a:lvl7pPr>
            <a:lvl8pPr marL="4536030" indent="0">
              <a:buNone/>
              <a:defRPr sz="2268" b="1"/>
            </a:lvl8pPr>
            <a:lvl9pPr marL="5184033" indent="0">
              <a:buNone/>
              <a:defRPr sz="2268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92715" y="8021460"/>
            <a:ext cx="5482835" cy="1179835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561180" y="5383224"/>
            <a:ext cx="5509837" cy="2638235"/>
          </a:xfrm>
        </p:spPr>
        <p:txBody>
          <a:bodyPr anchor="b"/>
          <a:lstStyle>
            <a:lvl1pPr marL="0" indent="0">
              <a:buNone/>
              <a:defRPr sz="3402" b="1"/>
            </a:lvl1pPr>
            <a:lvl2pPr marL="648004" indent="0">
              <a:buNone/>
              <a:defRPr sz="2835" b="1"/>
            </a:lvl2pPr>
            <a:lvl3pPr marL="1296008" indent="0">
              <a:buNone/>
              <a:defRPr sz="2551" b="1"/>
            </a:lvl3pPr>
            <a:lvl4pPr marL="1944013" indent="0">
              <a:buNone/>
              <a:defRPr sz="2268" b="1"/>
            </a:lvl4pPr>
            <a:lvl5pPr marL="2592017" indent="0">
              <a:buNone/>
              <a:defRPr sz="2268" b="1"/>
            </a:lvl5pPr>
            <a:lvl6pPr marL="3240020" indent="0">
              <a:buNone/>
              <a:defRPr sz="2268" b="1"/>
            </a:lvl6pPr>
            <a:lvl7pPr marL="3888025" indent="0">
              <a:buNone/>
              <a:defRPr sz="2268" b="1"/>
            </a:lvl7pPr>
            <a:lvl8pPr marL="4536030" indent="0">
              <a:buNone/>
              <a:defRPr sz="2268" b="1"/>
            </a:lvl8pPr>
            <a:lvl9pPr marL="5184033" indent="0">
              <a:buNone/>
              <a:defRPr sz="2268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561180" y="8021460"/>
            <a:ext cx="5509837" cy="1179835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F85AAA-86E6-4820-B832-9D5BB2BD7504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2441098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D3C208-5E4C-41D1-9C78-730AEC10AC88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42151795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B92E73-36E3-4BA5-A847-F77E213AA44F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5142106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92712" y="1463993"/>
            <a:ext cx="4180050" cy="5123974"/>
          </a:xfrm>
        </p:spPr>
        <p:txBody>
          <a:bodyPr anchor="b"/>
          <a:lstStyle>
            <a:lvl1pPr>
              <a:defRPr sz="4536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509839" y="3161822"/>
            <a:ext cx="6561177" cy="15605754"/>
          </a:xfrm>
        </p:spPr>
        <p:txBody>
          <a:bodyPr/>
          <a:lstStyle>
            <a:lvl1pPr>
              <a:defRPr sz="4536"/>
            </a:lvl1pPr>
            <a:lvl2pPr>
              <a:defRPr sz="3968"/>
            </a:lvl2pPr>
            <a:lvl3pPr>
              <a:defRPr sz="3402"/>
            </a:lvl3pPr>
            <a:lvl4pPr>
              <a:defRPr sz="2835"/>
            </a:lvl4pPr>
            <a:lvl5pPr>
              <a:defRPr sz="2835"/>
            </a:lvl5pPr>
            <a:lvl6pPr>
              <a:defRPr sz="2835"/>
            </a:lvl6pPr>
            <a:lvl7pPr>
              <a:defRPr sz="2835"/>
            </a:lvl7pPr>
            <a:lvl8pPr>
              <a:defRPr sz="2835"/>
            </a:lvl8pPr>
            <a:lvl9pPr>
              <a:defRPr sz="2835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92712" y="6587967"/>
            <a:ext cx="4180050" cy="12205023"/>
          </a:xfrm>
        </p:spPr>
        <p:txBody>
          <a:bodyPr/>
          <a:lstStyle>
            <a:lvl1pPr marL="0" indent="0">
              <a:buNone/>
              <a:defRPr sz="2268"/>
            </a:lvl1pPr>
            <a:lvl2pPr marL="648004" indent="0">
              <a:buNone/>
              <a:defRPr sz="1984"/>
            </a:lvl2pPr>
            <a:lvl3pPr marL="1296008" indent="0">
              <a:buNone/>
              <a:defRPr sz="1701"/>
            </a:lvl3pPr>
            <a:lvl4pPr marL="1944013" indent="0">
              <a:buNone/>
              <a:defRPr sz="1418"/>
            </a:lvl4pPr>
            <a:lvl5pPr marL="2592017" indent="0">
              <a:buNone/>
              <a:defRPr sz="1418"/>
            </a:lvl5pPr>
            <a:lvl6pPr marL="3240020" indent="0">
              <a:buNone/>
              <a:defRPr sz="1418"/>
            </a:lvl6pPr>
            <a:lvl7pPr marL="3888025" indent="0">
              <a:buNone/>
              <a:defRPr sz="1418"/>
            </a:lvl7pPr>
            <a:lvl8pPr marL="4536030" indent="0">
              <a:buNone/>
              <a:defRPr sz="1418"/>
            </a:lvl8pPr>
            <a:lvl9pPr marL="5184033" indent="0">
              <a:buNone/>
              <a:defRPr sz="1418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7ED3DE-4B30-48B5-95BB-DF6A3298C28C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910707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92712" y="1463993"/>
            <a:ext cx="4180050" cy="5123974"/>
          </a:xfrm>
        </p:spPr>
        <p:txBody>
          <a:bodyPr anchor="b"/>
          <a:lstStyle>
            <a:lvl1pPr>
              <a:defRPr sz="4536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509839" y="3161822"/>
            <a:ext cx="6561177" cy="15605754"/>
          </a:xfrm>
        </p:spPr>
        <p:txBody>
          <a:bodyPr anchor="t"/>
          <a:lstStyle>
            <a:lvl1pPr marL="0" indent="0">
              <a:buNone/>
              <a:defRPr sz="4536"/>
            </a:lvl1pPr>
            <a:lvl2pPr marL="648004" indent="0">
              <a:buNone/>
              <a:defRPr sz="3968"/>
            </a:lvl2pPr>
            <a:lvl3pPr marL="1296008" indent="0">
              <a:buNone/>
              <a:defRPr sz="3402"/>
            </a:lvl3pPr>
            <a:lvl4pPr marL="1944013" indent="0">
              <a:buNone/>
              <a:defRPr sz="2835"/>
            </a:lvl4pPr>
            <a:lvl5pPr marL="2592017" indent="0">
              <a:buNone/>
              <a:defRPr sz="2835"/>
            </a:lvl5pPr>
            <a:lvl6pPr marL="3240020" indent="0">
              <a:buNone/>
              <a:defRPr sz="2835"/>
            </a:lvl6pPr>
            <a:lvl7pPr marL="3888025" indent="0">
              <a:buNone/>
              <a:defRPr sz="2835"/>
            </a:lvl7pPr>
            <a:lvl8pPr marL="4536030" indent="0">
              <a:buNone/>
              <a:defRPr sz="2835"/>
            </a:lvl8pPr>
            <a:lvl9pPr marL="5184033" indent="0">
              <a:buNone/>
              <a:defRPr sz="2835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92712" y="6587967"/>
            <a:ext cx="4180050" cy="12205023"/>
          </a:xfrm>
        </p:spPr>
        <p:txBody>
          <a:bodyPr/>
          <a:lstStyle>
            <a:lvl1pPr marL="0" indent="0">
              <a:buNone/>
              <a:defRPr sz="2268"/>
            </a:lvl1pPr>
            <a:lvl2pPr marL="648004" indent="0">
              <a:buNone/>
              <a:defRPr sz="1984"/>
            </a:lvl2pPr>
            <a:lvl3pPr marL="1296008" indent="0">
              <a:buNone/>
              <a:defRPr sz="1701"/>
            </a:lvl3pPr>
            <a:lvl4pPr marL="1944013" indent="0">
              <a:buNone/>
              <a:defRPr sz="1418"/>
            </a:lvl4pPr>
            <a:lvl5pPr marL="2592017" indent="0">
              <a:buNone/>
              <a:defRPr sz="1418"/>
            </a:lvl5pPr>
            <a:lvl6pPr marL="3240020" indent="0">
              <a:buNone/>
              <a:defRPr sz="1418"/>
            </a:lvl6pPr>
            <a:lvl7pPr marL="3888025" indent="0">
              <a:buNone/>
              <a:defRPr sz="1418"/>
            </a:lvl7pPr>
            <a:lvl8pPr marL="4536030" indent="0">
              <a:buNone/>
              <a:defRPr sz="1418"/>
            </a:lvl8pPr>
            <a:lvl9pPr marL="5184033" indent="0">
              <a:buNone/>
              <a:defRPr sz="1418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6E1A72-34A7-4777-9297-BECAC6DDF237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9121506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91024" y="1169166"/>
            <a:ext cx="11178302" cy="4244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91024" y="5845805"/>
            <a:ext cx="11178302" cy="1393334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91026" y="20353569"/>
            <a:ext cx="2916079" cy="11691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0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3E6F1D-3C5F-40DC-B246-DD4AB1E6FA63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293116" y="20353569"/>
            <a:ext cx="4374118" cy="11691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0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153249" y="20353569"/>
            <a:ext cx="2916079" cy="11691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0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1109336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hf sldNum="0" hdr="0" ftr="0" dt="0"/>
  <p:txStyles>
    <p:titleStyle>
      <a:lvl1pPr algn="l" defTabSz="1296008" rtl="0" eaLnBrk="1" latinLnBrk="1" hangingPunct="1">
        <a:lnSpc>
          <a:spcPct val="90000"/>
        </a:lnSpc>
        <a:spcBef>
          <a:spcPct val="0"/>
        </a:spcBef>
        <a:buNone/>
        <a:defRPr sz="623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24003" indent="-324003" algn="l" defTabSz="1296008" rtl="0" eaLnBrk="1" latinLnBrk="1" hangingPunct="1">
        <a:lnSpc>
          <a:spcPct val="90000"/>
        </a:lnSpc>
        <a:spcBef>
          <a:spcPts val="1418"/>
        </a:spcBef>
        <a:buFont typeface="Arial" panose="020B0604020202020204" pitchFamily="34" charset="0"/>
        <a:buChar char="•"/>
        <a:defRPr sz="3968" kern="1200">
          <a:solidFill>
            <a:schemeClr val="tx1"/>
          </a:solidFill>
          <a:latin typeface="+mn-lt"/>
          <a:ea typeface="+mn-ea"/>
          <a:cs typeface="+mn-cs"/>
        </a:defRPr>
      </a:lvl1pPr>
      <a:lvl2pPr marL="972007" indent="-324003" algn="l" defTabSz="1296008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3402" kern="1200">
          <a:solidFill>
            <a:schemeClr val="tx1"/>
          </a:solidFill>
          <a:latin typeface="+mn-lt"/>
          <a:ea typeface="+mn-ea"/>
          <a:cs typeface="+mn-cs"/>
        </a:defRPr>
      </a:lvl2pPr>
      <a:lvl3pPr marL="1620010" indent="-324003" algn="l" defTabSz="1296008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3pPr>
      <a:lvl4pPr marL="2268014" indent="-324003" algn="l" defTabSz="1296008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2551" kern="1200">
          <a:solidFill>
            <a:schemeClr val="tx1"/>
          </a:solidFill>
          <a:latin typeface="+mn-lt"/>
          <a:ea typeface="+mn-ea"/>
          <a:cs typeface="+mn-cs"/>
        </a:defRPr>
      </a:lvl4pPr>
      <a:lvl5pPr marL="2916020" indent="-324003" algn="l" defTabSz="1296008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2551" kern="1200">
          <a:solidFill>
            <a:schemeClr val="tx1"/>
          </a:solidFill>
          <a:latin typeface="+mn-lt"/>
          <a:ea typeface="+mn-ea"/>
          <a:cs typeface="+mn-cs"/>
        </a:defRPr>
      </a:lvl5pPr>
      <a:lvl6pPr marL="3564023" indent="-324003" algn="l" defTabSz="1296008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2551" kern="1200">
          <a:solidFill>
            <a:schemeClr val="tx1"/>
          </a:solidFill>
          <a:latin typeface="+mn-lt"/>
          <a:ea typeface="+mn-ea"/>
          <a:cs typeface="+mn-cs"/>
        </a:defRPr>
      </a:lvl6pPr>
      <a:lvl7pPr marL="4212027" indent="-324003" algn="l" defTabSz="1296008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2551" kern="1200">
          <a:solidFill>
            <a:schemeClr val="tx1"/>
          </a:solidFill>
          <a:latin typeface="+mn-lt"/>
          <a:ea typeface="+mn-ea"/>
          <a:cs typeface="+mn-cs"/>
        </a:defRPr>
      </a:lvl7pPr>
      <a:lvl8pPr marL="4860032" indent="-324003" algn="l" defTabSz="1296008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2551" kern="1200">
          <a:solidFill>
            <a:schemeClr val="tx1"/>
          </a:solidFill>
          <a:latin typeface="+mn-lt"/>
          <a:ea typeface="+mn-ea"/>
          <a:cs typeface="+mn-cs"/>
        </a:defRPr>
      </a:lvl8pPr>
      <a:lvl9pPr marL="5508036" indent="-324003" algn="l" defTabSz="1296008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255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1pPr>
      <a:lvl2pPr marL="648004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2pPr>
      <a:lvl3pPr marL="1296008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3pPr>
      <a:lvl4pPr marL="1944013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4pPr>
      <a:lvl5pPr marL="2592017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5pPr>
      <a:lvl6pPr marL="3240020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6pPr>
      <a:lvl7pPr marL="3888025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7pPr>
      <a:lvl8pPr marL="4536030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8pPr>
      <a:lvl9pPr marL="5184033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표 4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2517990679"/>
              </p:ext>
            </p:extLst>
          </p:nvPr>
        </p:nvGraphicFramePr>
        <p:xfrm>
          <a:off x="76160" y="1162262"/>
          <a:ext cx="12834550" cy="891403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311902">
                  <a:extLst>
                    <a:ext uri="{9D8B030D-6E8A-4147-A177-3AD203B41FA5}">
                      <a16:colId xmlns:a16="http://schemas.microsoft.com/office/drawing/2014/main" xmlns="" val="1409189042"/>
                    </a:ext>
                  </a:extLst>
                </a:gridCol>
                <a:gridCol w="116840">
                  <a:extLst>
                    <a:ext uri="{9D8B030D-6E8A-4147-A177-3AD203B41FA5}">
                      <a16:colId xmlns:a16="http://schemas.microsoft.com/office/drawing/2014/main" xmlns="" val="1870204054"/>
                    </a:ext>
                  </a:extLst>
                </a:gridCol>
                <a:gridCol w="896112">
                  <a:extLst>
                    <a:ext uri="{9D8B030D-6E8A-4147-A177-3AD203B41FA5}">
                      <a16:colId xmlns:a16="http://schemas.microsoft.com/office/drawing/2014/main" xmlns="" val="2447889002"/>
                    </a:ext>
                  </a:extLst>
                </a:gridCol>
                <a:gridCol w="1024128">
                  <a:extLst>
                    <a:ext uri="{9D8B030D-6E8A-4147-A177-3AD203B41FA5}">
                      <a16:colId xmlns:a16="http://schemas.microsoft.com/office/drawing/2014/main" xmlns="" val="4088979873"/>
                    </a:ext>
                  </a:extLst>
                </a:gridCol>
                <a:gridCol w="4563066">
                  <a:extLst>
                    <a:ext uri="{9D8B030D-6E8A-4147-A177-3AD203B41FA5}">
                      <a16:colId xmlns:a16="http://schemas.microsoft.com/office/drawing/2014/main" xmlns="" val="120783647"/>
                    </a:ext>
                  </a:extLst>
                </a:gridCol>
                <a:gridCol w="898359">
                  <a:extLst>
                    <a:ext uri="{9D8B030D-6E8A-4147-A177-3AD203B41FA5}">
                      <a16:colId xmlns:a16="http://schemas.microsoft.com/office/drawing/2014/main" xmlns="" val="3270725404"/>
                    </a:ext>
                  </a:extLst>
                </a:gridCol>
                <a:gridCol w="1267327">
                  <a:extLst>
                    <a:ext uri="{9D8B030D-6E8A-4147-A177-3AD203B41FA5}">
                      <a16:colId xmlns:a16="http://schemas.microsoft.com/office/drawing/2014/main" xmlns="" val="3683565691"/>
                    </a:ext>
                  </a:extLst>
                </a:gridCol>
                <a:gridCol w="850231">
                  <a:extLst>
                    <a:ext uri="{9D8B030D-6E8A-4147-A177-3AD203B41FA5}">
                      <a16:colId xmlns:a16="http://schemas.microsoft.com/office/drawing/2014/main" xmlns="" val="3525253308"/>
                    </a:ext>
                  </a:extLst>
                </a:gridCol>
                <a:gridCol w="906585">
                  <a:extLst>
                    <a:ext uri="{9D8B030D-6E8A-4147-A177-3AD203B41FA5}">
                      <a16:colId xmlns:a16="http://schemas.microsoft.com/office/drawing/2014/main" xmlns="" val="2749235395"/>
                    </a:ext>
                  </a:extLst>
                </a:gridCol>
              </a:tblGrid>
              <a:tr h="404646">
                <a:tc rowSpan="2" gridSpan="2">
                  <a:txBody>
                    <a:bodyPr/>
                    <a:lstStyle/>
                    <a:p>
                      <a:pPr algn="l" latinLnBrk="1">
                        <a:lnSpc>
                          <a:spcPct val="80000"/>
                        </a:lnSpc>
                      </a:pP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.          Study 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400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 hMerge="1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FS/ME</a:t>
                      </a:r>
                      <a:r>
                        <a:rPr lang="en-US" altLang="ko-KR" sz="1500" baseline="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ases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se</a:t>
                      </a:r>
                      <a:r>
                        <a:rPr lang="en-US" altLang="ko-KR" sz="1500" baseline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 of Interview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cidence Rate (%)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te (%) 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%-CI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eight %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506282246"/>
                  </a:ext>
                </a:extLst>
              </a:tr>
              <a:tr h="404646">
                <a:tc gridSpan="2"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xed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ndom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204242281"/>
                  </a:ext>
                </a:extLst>
              </a:tr>
              <a:tr h="301176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Shi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8 [32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139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5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9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77; 1.05]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102593090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van't Leven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0 [68]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9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062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98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80; 1.21]  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052930925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Kim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S, 2008 [70]   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44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6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01; 0.43]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6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943389006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Kim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SH, 2008 [71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1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4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15; 1.10]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7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78963373"/>
                  </a:ext>
                </a:extLst>
              </a:tr>
              <a:tr h="313038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aralikar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7 [73]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4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74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0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4.10; 6.14] 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540650023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Rimes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7 [74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42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48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18; 1.27]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7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029290213"/>
                  </a:ext>
                </a:extLst>
              </a:tr>
              <a:tr h="296561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Furberg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5 [75]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6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91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7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2.30; 3.27]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7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003153161"/>
                  </a:ext>
                </a:extLst>
              </a:tr>
              <a:tr h="313038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Evangard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5 [76]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32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405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33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2.17; 2.51]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6.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746927803"/>
                  </a:ext>
                </a:extLst>
              </a:tr>
              <a:tr h="313038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Yiu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5 [77]  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5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1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.4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5.03;</a:t>
                      </a:r>
                      <a:r>
                        <a:rPr lang="en-US" altLang="ko-KR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.18]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877213210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uibers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4 [78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9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499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6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3.15; 4.16]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7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83606399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Farmer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4 [80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68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38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1.71; 3.32]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7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607206588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halder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3 [81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40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09; 0.38]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8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991075489"/>
                  </a:ext>
                </a:extLst>
              </a:tr>
              <a:tr h="79586">
                <a:tc rowSpan="2"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Lindal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2 [34] 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2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20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810402986"/>
                  </a:ext>
                </a:extLst>
              </a:tr>
              <a:tr h="229190">
                <a:tc gridSpan="2"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.6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6.61; 8.78]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.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532597414"/>
                  </a:ext>
                </a:extLst>
              </a:tr>
              <a:tr h="313038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Lindal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2 [34]  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4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20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1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1.64;</a:t>
                      </a:r>
                      <a:r>
                        <a:rPr lang="en-US" altLang="ko-KR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80]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788226694"/>
                  </a:ext>
                </a:extLst>
              </a:tr>
              <a:tr h="296561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Lindal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2 [34]  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20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00; 0.32]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785630432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Lindal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2 [34] 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4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20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73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3.05;</a:t>
                      </a:r>
                      <a:r>
                        <a:rPr lang="en-US" altLang="ko-KR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.57]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424452647"/>
                  </a:ext>
                </a:extLst>
              </a:tr>
              <a:tr h="313038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Steele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8 [87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627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23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16; 0.32]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7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071657"/>
                  </a:ext>
                </a:extLst>
              </a:tr>
              <a:tr h="313038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Fukuda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7 [88]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8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89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43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2.65; 4.44]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3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40685595"/>
                  </a:ext>
                </a:extLst>
              </a:tr>
              <a:tr h="313038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inowa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nd</a:t>
                      </a:r>
                      <a:r>
                        <a:rPr lang="en-US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Jiamo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6 [90]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5500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6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54; 0.66]  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.6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862505575"/>
                  </a:ext>
                </a:extLst>
              </a:tr>
              <a:tr h="313038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Lawrie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nd</a:t>
                      </a:r>
                      <a:r>
                        <a:rPr lang="en-US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Pelosi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5  [60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95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58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22; 1.53]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035610692"/>
                  </a:ext>
                </a:extLst>
              </a:tr>
              <a:tr h="296561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Jason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3 [93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74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75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41; 1.35]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8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461192299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rice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2 [33]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538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00; 0.05]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6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601623896"/>
                  </a:ext>
                </a:extLst>
              </a:tr>
              <a:tr h="369205">
                <a:tc gridSpan="2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en-US" altLang="ko-KR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20000"/>
                        </a:lnSpc>
                      </a:pPr>
                      <a:endParaRPr lang="en-US" altLang="ko-KR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20000"/>
                        </a:lnSpc>
                      </a:pPr>
                      <a:endParaRPr lang="en-US" altLang="ko-KR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20000"/>
                        </a:lnSpc>
                      </a:pPr>
                      <a:r>
                        <a:rPr lang="en-US" altLang="ko-KR" sz="15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</a:p>
                    <a:p>
                      <a:pPr latinLnBrk="1">
                        <a:lnSpc>
                          <a:spcPct val="20000"/>
                        </a:lnSpc>
                      </a:pPr>
                      <a:r>
                        <a:rPr lang="en-US" altLang="ko-KR" sz="15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xed effect model </a:t>
                      </a:r>
                      <a:endParaRPr lang="ko-KR" altLang="en-US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40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9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1.91; 2.08]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.0%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-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014201241"/>
                  </a:ext>
                </a:extLst>
              </a:tr>
              <a:tr h="311464">
                <a:tc gridSpan="3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20000"/>
                        </a:lnSpc>
                      </a:pPr>
                      <a:endParaRPr lang="en-US" altLang="ko-KR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20000"/>
                        </a:lnSpc>
                      </a:pPr>
                      <a:r>
                        <a:rPr lang="en-US" altLang="ko-KR" sz="15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ndom</a:t>
                      </a:r>
                      <a:r>
                        <a:rPr lang="en-US" altLang="ko-KR" sz="1500" b="1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500" b="1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ffects model</a:t>
                      </a:r>
                      <a:endParaRPr lang="ko-KR" altLang="en-US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4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1.14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0.76; 1.72]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-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.0%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257745429"/>
                  </a:ext>
                </a:extLst>
              </a:tr>
              <a:tr h="556781"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r>
                        <a:rPr lang="en-US" altLang="ko-KR" sz="15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terogeneity </a:t>
                      </a:r>
                      <a:endParaRPr lang="ko-KR" altLang="en-US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4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latinLnBrk="1">
                        <a:lnSpc>
                          <a:spcPct val="150000"/>
                        </a:lnSpc>
                      </a:pPr>
                      <a:r>
                        <a:rPr lang="en-US" altLang="ko-KR" sz="1500" i="1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r>
                        <a:rPr lang="en-US" altLang="ko-KR" sz="1500" baseline="300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= 98.7%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latinLnBrk="1">
                        <a:lnSpc>
                          <a:spcPct val="150000"/>
                        </a:lnSpc>
                      </a:pPr>
                      <a:r>
                        <a:rPr lang="en-US" altLang="ko-KR" sz="1500" i="1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</a:t>
                      </a:r>
                      <a:r>
                        <a:rPr lang="en-US" altLang="ko-KR" sz="1500" baseline="300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= 0.8269</a:t>
                      </a:r>
                    </a:p>
                    <a:p>
                      <a:pPr marL="0" marR="0" lvl="0" indent="0" algn="l" defTabSz="1320759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500" i="1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=</a:t>
                      </a:r>
                      <a:r>
                        <a:rPr lang="en-US" altLang="ko-KR" sz="1500" baseline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0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838004142"/>
                  </a:ext>
                </a:extLst>
              </a:tr>
            </a:tbl>
          </a:graphicData>
        </a:graphic>
      </p:graphicFrame>
      <p:sp>
        <p:nvSpPr>
          <p:cNvPr id="42" name="TextBox 41"/>
          <p:cNvSpPr txBox="1"/>
          <p:nvPr/>
        </p:nvSpPr>
        <p:spPr>
          <a:xfrm>
            <a:off x="76160" y="829506"/>
            <a:ext cx="1245056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6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ta-analysis of CFS/ME prevalence by interview (A) and interview with medical test (B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ko-K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4" name="표 4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977405059"/>
              </p:ext>
            </p:extLst>
          </p:nvPr>
        </p:nvGraphicFramePr>
        <p:xfrm>
          <a:off x="76160" y="10051466"/>
          <a:ext cx="12834550" cy="90225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483606">
                  <a:extLst>
                    <a:ext uri="{9D8B030D-6E8A-4147-A177-3AD203B41FA5}">
                      <a16:colId xmlns:a16="http://schemas.microsoft.com/office/drawing/2014/main" xmlns="" val="1409189042"/>
                    </a:ext>
                  </a:extLst>
                </a:gridCol>
                <a:gridCol w="146304">
                  <a:extLst>
                    <a:ext uri="{9D8B030D-6E8A-4147-A177-3AD203B41FA5}">
                      <a16:colId xmlns:a16="http://schemas.microsoft.com/office/drawing/2014/main" xmlns="" val="2073942065"/>
                    </a:ext>
                  </a:extLst>
                </a:gridCol>
                <a:gridCol w="877824">
                  <a:extLst>
                    <a:ext uri="{9D8B030D-6E8A-4147-A177-3AD203B41FA5}">
                      <a16:colId xmlns:a16="http://schemas.microsoft.com/office/drawing/2014/main" xmlns="" val="815288012"/>
                    </a:ext>
                  </a:extLst>
                </a:gridCol>
                <a:gridCol w="1133856">
                  <a:extLst>
                    <a:ext uri="{9D8B030D-6E8A-4147-A177-3AD203B41FA5}">
                      <a16:colId xmlns:a16="http://schemas.microsoft.com/office/drawing/2014/main" xmlns="" val="4088979873"/>
                    </a:ext>
                  </a:extLst>
                </a:gridCol>
                <a:gridCol w="4270458">
                  <a:extLst>
                    <a:ext uri="{9D8B030D-6E8A-4147-A177-3AD203B41FA5}">
                      <a16:colId xmlns:a16="http://schemas.microsoft.com/office/drawing/2014/main" xmlns="" val="120783647"/>
                    </a:ext>
                  </a:extLst>
                </a:gridCol>
                <a:gridCol w="898359">
                  <a:extLst>
                    <a:ext uri="{9D8B030D-6E8A-4147-A177-3AD203B41FA5}">
                      <a16:colId xmlns:a16="http://schemas.microsoft.com/office/drawing/2014/main" xmlns="" val="3270725404"/>
                    </a:ext>
                  </a:extLst>
                </a:gridCol>
                <a:gridCol w="1267327">
                  <a:extLst>
                    <a:ext uri="{9D8B030D-6E8A-4147-A177-3AD203B41FA5}">
                      <a16:colId xmlns:a16="http://schemas.microsoft.com/office/drawing/2014/main" xmlns="" val="3683565691"/>
                    </a:ext>
                  </a:extLst>
                </a:gridCol>
                <a:gridCol w="850231">
                  <a:extLst>
                    <a:ext uri="{9D8B030D-6E8A-4147-A177-3AD203B41FA5}">
                      <a16:colId xmlns:a16="http://schemas.microsoft.com/office/drawing/2014/main" xmlns="" val="3525253308"/>
                    </a:ext>
                  </a:extLst>
                </a:gridCol>
                <a:gridCol w="906585">
                  <a:extLst>
                    <a:ext uri="{9D8B030D-6E8A-4147-A177-3AD203B41FA5}">
                      <a16:colId xmlns:a16="http://schemas.microsoft.com/office/drawing/2014/main" xmlns="" val="2749235395"/>
                    </a:ext>
                  </a:extLst>
                </a:gridCol>
              </a:tblGrid>
              <a:tr h="404646">
                <a:tc rowSpan="2" gridSpan="2">
                  <a:txBody>
                    <a:bodyPr/>
                    <a:lstStyle/>
                    <a:p>
                      <a:pPr algn="l" latinLnBrk="1">
                        <a:lnSpc>
                          <a:spcPct val="80000"/>
                        </a:lnSpc>
                      </a:pP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.           Study 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400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FS/ME</a:t>
                      </a:r>
                      <a:r>
                        <a:rPr lang="en-US" altLang="ko-KR" sz="1500" baseline="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ases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ses o</a:t>
                      </a:r>
                      <a:r>
                        <a:rPr lang="en-US" altLang="ko-KR" sz="1500" baseline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 </a:t>
                      </a:r>
                      <a:r>
                        <a:rPr lang="en-US" altLang="ko-KR" sz="1500" baseline="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erview +</a:t>
                      </a:r>
                      <a:endParaRPr lang="en-US" altLang="ko-KR" sz="1500" baseline="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baseline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dical test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cidence Rate (%)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te (%) 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%-CI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eight %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506282246"/>
                  </a:ext>
                </a:extLst>
              </a:tr>
              <a:tr h="404646">
                <a:tc gridSpan="2"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xed 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ndom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971989698"/>
                  </a:ext>
                </a:extLst>
              </a:tr>
              <a:tr h="296561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amaguchi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1 [66]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30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5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98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58; 1.65]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3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3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562126362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ho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9 [69] 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1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59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07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1.58;</a:t>
                      </a:r>
                      <a:r>
                        <a:rPr lang="en-US" altLang="ko-KR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73]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78994920"/>
                  </a:ext>
                </a:extLst>
              </a:tr>
              <a:tr h="313038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ho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9 [69]  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14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6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1.26; 2.06]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13812699"/>
                  </a:ext>
                </a:extLst>
              </a:tr>
              <a:tr h="296561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Reeves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7 [72]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62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0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1.67; 2.42]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5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4252899567"/>
                  </a:ext>
                </a:extLst>
              </a:tr>
              <a:tr h="313038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Njoku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7 [50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87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28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09; 0.86]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937242282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Kim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H,</a:t>
                      </a:r>
                      <a:r>
                        <a:rPr lang="en-US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5 [55]   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48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6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33;</a:t>
                      </a:r>
                      <a:r>
                        <a:rPr lang="en-US" altLang="ko-KR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13] 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3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38437475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Jones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4 [79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586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3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23; 0.49]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5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114836199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Reyes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3 [54]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162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6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45; 0.81]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610182719"/>
                  </a:ext>
                </a:extLst>
              </a:tr>
              <a:tr h="296561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cCauley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2 [82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99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25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1.42; 3.58]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3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8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4023522958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Kim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H,</a:t>
                      </a:r>
                      <a:r>
                        <a:rPr lang="en-US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0 [83] 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8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2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69; 2.14]  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3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3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83586543"/>
                  </a:ext>
                </a:extLst>
              </a:tr>
              <a:tr h="296561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Ji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JD,</a:t>
                      </a:r>
                      <a:r>
                        <a:rPr lang="en-US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0 [84]  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26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03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1.43; 2.89]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7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783425823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Ji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JD,</a:t>
                      </a:r>
                      <a:r>
                        <a:rPr lang="en-US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9 [85]  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30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8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1.02; 3.51]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3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358115011"/>
                  </a:ext>
                </a:extLst>
              </a:tr>
              <a:tr h="296561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Jason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9 [53]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9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67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4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35; 0.50]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6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674072927"/>
                  </a:ext>
                </a:extLst>
              </a:tr>
              <a:tr h="322911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Jason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8 [86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00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79; 1.50]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7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848131884"/>
                  </a:ext>
                </a:extLst>
              </a:tr>
              <a:tr h="32951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Wessely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7 [16]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85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4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97; 2.04]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6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650182046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Wessely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7 [16]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2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85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6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2.00; 3.44] 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136350838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Wessely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7 [16]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85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2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81;</a:t>
                      </a:r>
                      <a:r>
                        <a:rPr lang="en-US" altLang="ko-KR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80]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5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163953607"/>
                  </a:ext>
                </a:extLst>
              </a:tr>
              <a:tr h="313038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Wessely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7 [16]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4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85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2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1.65; 2.98] 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682801446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Buchwald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nd</a:t>
                      </a:r>
                      <a:r>
                        <a:rPr lang="en-US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Umali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5 [91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66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03; 0.30]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956945739"/>
                  </a:ext>
                </a:extLst>
              </a:tr>
              <a:tr h="296561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Jason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5 [92]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1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2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05; 0.88] 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125116865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Bates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3 [39]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95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54;1.87]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3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343831562"/>
                  </a:ext>
                </a:extLst>
              </a:tr>
              <a:tr h="313038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Bates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3 [39]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95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3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10; 0.93] 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435511827"/>
                  </a:ext>
                </a:extLst>
              </a:tr>
              <a:tr h="280087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Bates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3 [39]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95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4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15;</a:t>
                      </a:r>
                      <a:r>
                        <a:rPr lang="en-US" altLang="ko-KR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7]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290518874"/>
                  </a:ext>
                </a:extLst>
              </a:tr>
              <a:tr h="369205">
                <a:tc gridSpan="3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en-US" altLang="ko-KR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20000"/>
                        </a:lnSpc>
                      </a:pPr>
                      <a:endParaRPr lang="en-US" altLang="ko-KR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20000"/>
                        </a:lnSpc>
                      </a:pPr>
                      <a:endParaRPr lang="en-US" altLang="ko-KR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20000"/>
                        </a:lnSpc>
                      </a:pPr>
                      <a:endParaRPr lang="en-US" altLang="ko-KR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20000"/>
                        </a:lnSpc>
                      </a:pPr>
                      <a:r>
                        <a:rPr lang="en-US" altLang="ko-KR" sz="15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xed effect model </a:t>
                      </a:r>
                      <a:endParaRPr lang="ko-KR" altLang="en-US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40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6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1.08; 1.25]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.0%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-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014201241"/>
                  </a:ext>
                </a:extLst>
              </a:tr>
              <a:tr h="189646">
                <a:tc gridSpan="3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20000"/>
                        </a:lnSpc>
                      </a:pPr>
                      <a:endParaRPr lang="en-US" altLang="ko-KR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20000"/>
                        </a:lnSpc>
                      </a:pPr>
                      <a:r>
                        <a:rPr lang="en-US" altLang="ko-KR" sz="15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ndom</a:t>
                      </a:r>
                      <a:r>
                        <a:rPr lang="en-US" altLang="ko-KR" sz="1500" b="1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500" b="1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ffects </a:t>
                      </a:r>
                      <a:r>
                        <a:rPr lang="en-US" altLang="ko-KR" sz="1500" b="1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l</a:t>
                      </a:r>
                      <a:endParaRPr lang="ko-KR" altLang="en-US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4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0.95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0.69; 1.31]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-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.0%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257745429"/>
                  </a:ext>
                </a:extLst>
              </a:tr>
              <a:tr h="556781"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r>
                        <a:rPr lang="en-US" altLang="ko-KR" sz="15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terogeneity </a:t>
                      </a:r>
                      <a:endParaRPr lang="ko-KR" altLang="en-US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4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latinLnBrk="1">
                        <a:lnSpc>
                          <a:spcPct val="150000"/>
                        </a:lnSpc>
                      </a:pPr>
                      <a:r>
                        <a:rPr lang="en-US" altLang="ko-KR" sz="1500" i="1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r>
                        <a:rPr lang="en-US" altLang="ko-KR" sz="1500" baseline="300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 94.0%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l" latinLnBrk="1">
                        <a:lnSpc>
                          <a:spcPct val="150000"/>
                        </a:lnSpc>
                      </a:pP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latinLnBrk="1">
                        <a:lnSpc>
                          <a:spcPct val="150000"/>
                        </a:lnSpc>
                      </a:pPr>
                      <a:r>
                        <a:rPr lang="en-US" altLang="ko-KR" sz="1500" i="1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</a:t>
                      </a:r>
                      <a:r>
                        <a:rPr lang="en-US" altLang="ko-KR" sz="1500" baseline="300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= 0.5208</a:t>
                      </a:r>
                    </a:p>
                    <a:p>
                      <a:pPr marL="0" marR="0" lvl="0" indent="0" algn="l" defTabSz="1320759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500" i="1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&lt;0.01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838004142"/>
                  </a:ext>
                </a:extLst>
              </a:tr>
            </a:tbl>
          </a:graphicData>
        </a:graphic>
      </p:graphicFrame>
      <p:grpSp>
        <p:nvGrpSpPr>
          <p:cNvPr id="45" name="그룹 44"/>
          <p:cNvGrpSpPr/>
          <p:nvPr/>
        </p:nvGrpSpPr>
        <p:grpSpPr>
          <a:xfrm>
            <a:off x="4565251" y="10748488"/>
            <a:ext cx="5740399" cy="8306061"/>
            <a:chOff x="4034737" y="10614287"/>
            <a:chExt cx="5740399" cy="8306061"/>
          </a:xfrm>
        </p:grpSpPr>
        <p:pic>
          <p:nvPicPr>
            <p:cNvPr id="46" name="그림 45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4103387" y="10614287"/>
              <a:ext cx="4354813" cy="7588516"/>
            </a:xfrm>
            <a:prstGeom prst="rect">
              <a:avLst/>
            </a:prstGeom>
          </p:spPr>
        </p:pic>
        <p:grpSp>
          <p:nvGrpSpPr>
            <p:cNvPr id="47" name="그룹 46"/>
            <p:cNvGrpSpPr/>
            <p:nvPr/>
          </p:nvGrpSpPr>
          <p:grpSpPr>
            <a:xfrm>
              <a:off x="4034737" y="18447690"/>
              <a:ext cx="5740399" cy="472658"/>
              <a:chOff x="13375961" y="15424264"/>
              <a:chExt cx="5740399" cy="472658"/>
            </a:xfrm>
          </p:grpSpPr>
          <p:sp>
            <p:nvSpPr>
              <p:cNvPr id="48" name="TextBox 47"/>
              <p:cNvSpPr txBox="1"/>
              <p:nvPr/>
            </p:nvSpPr>
            <p:spPr>
              <a:xfrm>
                <a:off x="13375961" y="15578373"/>
                <a:ext cx="5740399" cy="3185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7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                    1.0                    2.0                   3.0                    4.0 (%)</a:t>
                </a:r>
                <a:endParaRPr lang="ko-KR" altLang="en-US" sz="147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49" name="그림 48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tretch>
                <a:fillRect/>
              </a:stretch>
            </p:blipFill>
            <p:spPr>
              <a:xfrm>
                <a:off x="13528361" y="15424264"/>
                <a:ext cx="4698720" cy="199843"/>
              </a:xfrm>
              <a:prstGeom prst="rect">
                <a:avLst/>
              </a:prstGeom>
            </p:spPr>
          </p:pic>
        </p:grpSp>
      </p:grpSp>
      <p:grpSp>
        <p:nvGrpSpPr>
          <p:cNvPr id="4" name="그룹 3"/>
          <p:cNvGrpSpPr/>
          <p:nvPr/>
        </p:nvGrpSpPr>
        <p:grpSpPr>
          <a:xfrm>
            <a:off x="4267001" y="1885765"/>
            <a:ext cx="5288234" cy="8136660"/>
            <a:chOff x="4267001" y="1885765"/>
            <a:chExt cx="5288234" cy="8136660"/>
          </a:xfrm>
        </p:grpSpPr>
        <p:pic>
          <p:nvPicPr>
            <p:cNvPr id="43" name="그림 42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4267001" y="1885765"/>
              <a:ext cx="4948202" cy="7339123"/>
            </a:xfrm>
            <a:prstGeom prst="rect">
              <a:avLst/>
            </a:prstGeom>
          </p:spPr>
        </p:pic>
        <p:grpSp>
          <p:nvGrpSpPr>
            <p:cNvPr id="13" name="그룹 12"/>
            <p:cNvGrpSpPr/>
            <p:nvPr/>
          </p:nvGrpSpPr>
          <p:grpSpPr>
            <a:xfrm>
              <a:off x="4303229" y="9580229"/>
              <a:ext cx="5252006" cy="442196"/>
              <a:chOff x="3979331" y="20038815"/>
              <a:chExt cx="5740399" cy="442196"/>
            </a:xfrm>
          </p:grpSpPr>
          <p:pic>
            <p:nvPicPr>
              <p:cNvPr id="14" name="그림 13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tretch>
                <a:fillRect/>
              </a:stretch>
            </p:blipFill>
            <p:spPr>
              <a:xfrm>
                <a:off x="4031500" y="20038815"/>
                <a:ext cx="5008735" cy="96533"/>
              </a:xfrm>
              <a:prstGeom prst="rect">
                <a:avLst/>
              </a:prstGeom>
            </p:spPr>
          </p:pic>
          <p:sp>
            <p:nvSpPr>
              <p:cNvPr id="15" name="TextBox 14"/>
              <p:cNvSpPr txBox="1"/>
              <p:nvPr/>
            </p:nvSpPr>
            <p:spPr>
              <a:xfrm>
                <a:off x="3979331" y="20162462"/>
                <a:ext cx="5740399" cy="3185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7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0     1.0     2.0      3.0      4.0     5.0     6.0     7.0      8.0      9.0 (%) </a:t>
                </a:r>
                <a:endParaRPr lang="ko-KR" altLang="en-US" sz="147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xmlns="" val="9835512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70</TotalTime>
  <Words>957</Words>
  <Application>Microsoft Office PowerPoint</Application>
  <PresentationFormat>Custom</PresentationFormat>
  <Paragraphs>62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테마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사용자</dc:creator>
  <cp:lastModifiedBy>0016236</cp:lastModifiedBy>
  <cp:revision>21</cp:revision>
  <cp:lastPrinted>2020-01-02T00:55:33Z</cp:lastPrinted>
  <dcterms:created xsi:type="dcterms:W3CDTF">2019-12-30T09:07:39Z</dcterms:created>
  <dcterms:modified xsi:type="dcterms:W3CDTF">2020-02-15T03:26:21Z</dcterms:modified>
</cp:coreProperties>
</file>